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 showGuides="1">
      <p:cViewPr varScale="1">
        <p:scale>
          <a:sx n="124" d="100"/>
          <a:sy n="124" d="100"/>
        </p:scale>
        <p:origin x="544" y="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620ECD-C7E0-3F3D-B055-229AE81708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E5DCA11-BD3C-34A5-F440-3B321D5184C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DFBCB3-4F55-57F4-A476-74B09B3320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8377C-05FD-864F-9544-862510637A1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480D74-819E-FD16-EE13-BA096F847F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C126C6-1709-1D12-3E9F-AC55DE8B77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610EA-1A11-994D-86EF-CEADEE86B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572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8CC32E-F4CF-74CE-C47C-FE2EBA5E68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46069A-CA31-D4D3-8E69-2852ABCC9E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965A4B-BAF8-6D92-C684-D4C99F242D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8377C-05FD-864F-9544-862510637A1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C3A51B-63BC-F64C-59C6-98E64F66AF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6C9E09-BCDD-036F-1E4C-7BBFB16D81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610EA-1A11-994D-86EF-CEADEE86B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62174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2A30CFE-FC8B-179F-F836-9567BBA06B2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CE430FA-5171-BF89-13F9-C317EDF374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DE166F-C845-44E0-C35B-C8D76E3F57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8377C-05FD-864F-9544-862510637A1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8CD03D-2EA1-3432-7936-64CDF1D9C2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A6DB12-DD11-7196-3A99-298B6A36E9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610EA-1A11-994D-86EF-CEADEE86B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01625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6FE9A4-5144-063D-1767-93B576E6A2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925428-CD3C-4437-FECB-813B19CAC7B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CC74AB-2477-60D5-083F-6181B08434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8377C-05FD-864F-9544-862510637A1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B12980-3197-1415-D007-7750BEEB7B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DA19C8-6C2E-4C15-1539-B922DC63CD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610EA-1A11-994D-86EF-CEADEE86B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980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1425A0-8AD6-CEAD-B37A-CE03BC3946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FDFEAE-40B4-030B-A880-262B86AF4A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D3D97B-4F92-5F75-EA3D-979E92FE7A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8377C-05FD-864F-9544-862510637A1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B846B7-8461-700D-D453-201DD9A6B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6DBE3A-2358-2EBC-E6C8-C5EC9383D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610EA-1A11-994D-86EF-CEADEE86B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754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912745-E36F-323B-F4CB-965D7C4731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3BAE9E-35B9-13C7-B8C9-5DB78DDFAED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C2F930-4B77-20CC-EC74-0A50E58557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4BFD3B-3413-17C8-E1FB-C4E1978F7B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8377C-05FD-864F-9544-862510637A1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F8EB8F-E954-32AA-783D-4EFCDC0954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AF2F3F-0C5C-CA6F-7FF1-DE067FF36F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610EA-1A11-994D-86EF-CEADEE86B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3931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ED89E1-93E2-39F9-29CD-110D7A5917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15A64E-BCD0-A600-7CF5-8A3F304763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F9008A-4AF8-62E0-5A7B-710D6915E9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0A62B33-D633-E32B-D596-581D86EAD6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9715AC1-444D-4EC5-4701-2B9068C46EA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AD74196-1BB4-F897-6D17-7CC779374B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8377C-05FD-864F-9544-862510637A1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D4C924B-4A84-B43D-EA3B-28F0CA810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ADE687F-A1D9-498E-0E0F-7FB1D122E2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610EA-1A11-994D-86EF-CEADEE86B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605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5D9226-3FF0-0D8E-AB5B-3430DF02BE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AC30D7D-0342-8CEA-63FB-AF75BEFE59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8377C-05FD-864F-9544-862510637A1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55D9D72-08B6-4C03-ADEC-CF3510A06A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B414726-D1BA-7C9C-C6C8-458B84A5F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610EA-1A11-994D-86EF-CEADEE86B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0550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035DE59-FA7C-27EF-E6D9-2569C2485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8377C-05FD-864F-9544-862510637A1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DFA0004-0BE0-7166-B3B6-3A5869A3E3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09008C9-A720-3332-4FC2-AA0563B10B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610EA-1A11-994D-86EF-CEADEE86B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6200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CCF1BC-027E-A41C-A9EC-B8DEAF6908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F3C2BA-69F9-D35B-1436-E7FA2A8800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73FD26-2E2E-CCB1-354B-ABE1E004D1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2D7423-F7A3-B1FA-FF17-648BD9DB7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8377C-05FD-864F-9544-862510637A1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ECC0C4-7007-9313-08F4-38AC7EE8AD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35530D-E2EF-7A69-B4F0-8A6AD0C470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610EA-1A11-994D-86EF-CEADEE86B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27289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32E2DA-5DE0-D426-14AB-531AAE79D0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B56B358-CC31-21AB-88E6-5055CB08E4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7518A18-7B2F-F636-2CFA-42991A6CB5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4E95D8-1C79-BC27-8F31-7AC0A627EC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8377C-05FD-864F-9544-862510637A1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7DCE14-50CA-8E79-3B73-60C0E5EA22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F07011-AC25-DCDB-2E05-ACAC4D54E9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610EA-1A11-994D-86EF-CEADEE86B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0637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2D26FC4-8635-204A-A13A-701D369022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59032C-5F50-61D4-2F1D-FD625A6B2C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B1EF70-B106-DA4E-52DF-208C5D3814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68377C-05FD-864F-9544-862510637A10}" type="datetimeFigureOut">
              <a:rPr lang="en-US" smtClean="0"/>
              <a:t>8/2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34AF6D-C1BB-68C1-5990-295EDCBAD8F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720D9D-C9DE-DB6D-C552-AA3750A2FED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9610EA-1A11-994D-86EF-CEADEE86B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8365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999548E3-A057-8F91-FDEE-4B20AA6C66D4}"/>
              </a:ext>
            </a:extLst>
          </p:cNvPr>
          <p:cNvGrpSpPr>
            <a:grpSpLocks noChangeAspect="1"/>
          </p:cNvGrpSpPr>
          <p:nvPr/>
        </p:nvGrpSpPr>
        <p:grpSpPr>
          <a:xfrm>
            <a:off x="4125724" y="1048862"/>
            <a:ext cx="3657600" cy="2800350"/>
            <a:chOff x="1617306" y="0"/>
            <a:chExt cx="8957388" cy="68580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5D554514-1A25-43EA-6B04-745A9D25EAE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17306" y="0"/>
              <a:ext cx="8957388" cy="6858000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E8EB653C-EDAA-8B9A-0A94-B2AC3399A2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alphaModFix/>
            </a:blip>
            <a:srcRect l="1618" t="7039" r="7472" b="-7039"/>
            <a:stretch/>
          </p:blipFill>
          <p:spPr>
            <a:xfrm>
              <a:off x="5201390" y="912555"/>
              <a:ext cx="3987870" cy="3289993"/>
            </a:xfrm>
            <a:prstGeom prst="rect">
              <a:avLst/>
            </a:prstGeom>
          </p:spPr>
        </p:pic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D621E2D8-25E9-18EA-6FED-F6F6378C0D4F}"/>
              </a:ext>
            </a:extLst>
          </p:cNvPr>
          <p:cNvGrpSpPr>
            <a:grpSpLocks noChangeAspect="1"/>
          </p:cNvGrpSpPr>
          <p:nvPr/>
        </p:nvGrpSpPr>
        <p:grpSpPr>
          <a:xfrm>
            <a:off x="7500370" y="1048862"/>
            <a:ext cx="3657600" cy="2800350"/>
            <a:chOff x="1617306" y="0"/>
            <a:chExt cx="8957388" cy="6858000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1E3C017-3349-F70B-74A7-685AAA1E978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17306" y="0"/>
              <a:ext cx="8957388" cy="68580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FE118E2D-232E-5F0D-0779-393E084ADF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737" r="7691" b="-2381"/>
            <a:stretch/>
          </p:blipFill>
          <p:spPr>
            <a:xfrm>
              <a:off x="5191765" y="2304472"/>
              <a:ext cx="4023360" cy="3291840"/>
            </a:xfrm>
            <a:prstGeom prst="rect">
              <a:avLst/>
            </a:prstGeom>
          </p:spPr>
        </p:pic>
      </p:grpSp>
      <p:pic>
        <p:nvPicPr>
          <p:cNvPr id="11" name="Picture 10">
            <a:extLst>
              <a:ext uri="{FF2B5EF4-FFF2-40B4-BE49-F238E27FC236}">
                <a16:creationId xmlns:a16="http://schemas.microsoft.com/office/drawing/2014/main" id="{71ACC650-1E86-BD8D-0A5F-2284C1615562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1078" y="1125062"/>
            <a:ext cx="3657600" cy="280035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2EDAB937-F8FD-A54E-6194-FE56E4A1ED68}"/>
              </a:ext>
            </a:extLst>
          </p:cNvPr>
          <p:cNvSpPr txBox="1"/>
          <p:nvPr/>
        </p:nvSpPr>
        <p:spPr>
          <a:xfrm>
            <a:off x="1227463" y="104886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4ED3441-DFEA-8884-1C27-FF9F4012BA40}"/>
              </a:ext>
            </a:extLst>
          </p:cNvPr>
          <p:cNvSpPr txBox="1"/>
          <p:nvPr/>
        </p:nvSpPr>
        <p:spPr>
          <a:xfrm>
            <a:off x="4726205" y="97266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2CC30E4-C5EA-98FB-D9BB-E28D3B6A9AA6}"/>
              </a:ext>
            </a:extLst>
          </p:cNvPr>
          <p:cNvSpPr txBox="1"/>
          <p:nvPr/>
        </p:nvSpPr>
        <p:spPr>
          <a:xfrm>
            <a:off x="8066089" y="94039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77142FF-5C9C-A056-875F-CF043B04F93E}"/>
              </a:ext>
            </a:extLst>
          </p:cNvPr>
          <p:cNvSpPr txBox="1"/>
          <p:nvPr/>
        </p:nvSpPr>
        <p:spPr>
          <a:xfrm>
            <a:off x="1331195" y="4051541"/>
            <a:ext cx="924665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Figure S2. Concentration-Dependent Chiroptical Profiles of Ipecac Alkaloids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Circular dichroism spectra of emetine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anel A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isoemetine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anel B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,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dehydroemetine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Panel C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 spanning the concentration range of 0.25 - 1.0 mg/mL in ethanol.  The insets of Panels B and C present expanded scales over the 250 – 300 nm wavelength region to improve visualization of the respective Cotton effects.</a:t>
            </a:r>
            <a:r>
              <a:rPr lang="en-US" sz="1200" dirty="0">
                <a:effectLst/>
              </a:rPr>
              <a:t>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5733463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4</Words>
  <Application>Microsoft Macintosh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mas Rosenquist</dc:creator>
  <cp:lastModifiedBy>Thomas Rosenquist</cp:lastModifiedBy>
  <cp:revision>2</cp:revision>
  <dcterms:created xsi:type="dcterms:W3CDTF">2023-08-24T19:26:07Z</dcterms:created>
  <dcterms:modified xsi:type="dcterms:W3CDTF">2023-08-24T19:34:03Z</dcterms:modified>
</cp:coreProperties>
</file>